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/>
    <p:restoredTop sz="83236" autoAdjust="0"/>
  </p:normalViewPr>
  <p:slideViewPr>
    <p:cSldViewPr snapToGrid="0" snapToObjects="1">
      <p:cViewPr varScale="1">
        <p:scale>
          <a:sx n="71" d="100"/>
          <a:sy n="71" d="100"/>
        </p:scale>
        <p:origin x="118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0DB312-CB85-B94B-828A-8DEABF9D9A1A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57626B-F84C-8945-902B-27FFBF303E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830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57626B-F84C-8945-902B-27FFBF303EB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4366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11F445-6E7A-5A4B-AADA-27238CA946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4C4B387-D505-DC42-9138-467BDF40AD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EE590A-10AC-664B-BE8F-2A8D92C6F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7B90AF-AEE3-E843-8E30-689B2A9E1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01F476-86B5-5A4E-B527-54DE3801E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387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C78AB9-C621-E248-B87F-E194AA9230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04DA99-FE1C-0A47-953A-EC192766AC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57A35A-8BE9-0F43-B276-A65E838D9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457E3B-8B80-574F-BB6B-70D980342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C0B87D-6C46-3241-95CB-40BB13664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802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0223B5-43AC-264C-9070-61F23194F1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FFD47A9-9B16-624C-9F1C-C4F40534A2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8C0F7C-F398-F94F-AC44-7666EE4AF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05DDB4-BA8F-DF4A-9DC2-2F8F029EB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BA7299-D2F2-CE4B-9E7D-A546FD4E9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514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58F3AF-56F7-3443-9C60-E99801BDE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D56921-B636-9A43-832E-8EC7E9C377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8F0091-AA1C-A94F-A0AB-F00B4C0EA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84977B-9892-8048-ACF1-AE17D5258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5066F2-5CF8-F546-8BBE-1D207F1E5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745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8B468A-1E5B-E14B-8992-D0313F9EB6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16511D1-461E-C849-A760-E7D52F7C36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02A79A-33FA-9F4F-87CA-FB9E0EFF1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8359D2-E79F-A641-BFC9-D3F0D8E7A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6C64D1-4108-4045-A17B-2AAF79D33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90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085805-F532-674B-B991-4012BFC116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B1304E-7122-C047-9B60-D50C7C4689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797855-0463-8740-A22C-A04DE84145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A35C9F-1F22-D348-B28A-7C25540D1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39D2C4-3AAA-A54F-9679-E411073FA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F65EEC-C995-6943-9CEC-28A9B1454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46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A3476B-FB01-3A43-975E-C626F1929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7B3608C-7D9C-794F-B66B-AB9BE067A7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A585E9-4FCA-7043-9FD9-F071FD461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C21CD49-03AF-514D-810A-22AED81646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F4B0AB1-419F-DF4E-A369-06F83B130A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783C372-39C2-C348-A133-282E51A30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DE3CA47-127A-2548-825A-037205841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26B3CE4-AF2A-7C47-893C-FAD79B7F1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231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8EFE36-A319-8A4C-A9BF-FDCFF7ED6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FA5F7C8-3012-254A-8B50-504B8A6D1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9764F9C-BB3D-354F-9C8F-42E966886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5C47624-3D05-DE49-B015-02D76F6A9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281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A42E171-5000-5741-8DFC-2235B67BE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94048AD-00C7-EF43-ACDF-3CBC7BA3D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31E2A-D3E8-7745-B933-790367620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5599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9C27F4-8F05-8B40-917D-6452889BD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4A5537E-5E16-B043-8B91-A919D1110C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79D77A-A1F8-F94E-94FF-AD82BD2D3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94629D-E1A1-E04F-A8B2-CC9F9E84A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ABF5762-DED0-E842-BF70-B17063C9A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94E2A5-CD4A-1C44-99FD-CA853B9AD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200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0473B1-D00E-4B46-A8FE-86864798C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BE37F05-72A6-9F4C-B9C5-D89242670F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B4593A7-A747-5942-A15D-C103C4CC63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A81CD0-92EC-364B-BA57-E8BD4AE36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578AEF-BB5F-0D40-B573-79B0362D5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F2BB1C-DE0E-634B-B72D-13A7862C9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319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526EB2D-2C77-2C41-954E-EDED08003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DC4784-B431-3841-914F-304EE87DE4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7BDF35-9208-4A4B-A449-C9D08B8A9A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69C1E-C045-3446-A6CF-FFA78ACA9893}" type="datetimeFigureOut">
              <a:rPr kumimoji="1" lang="ja-JP" altLang="en-US" smtClean="0"/>
              <a:t>2020/6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C798AB-0519-084D-AE06-115DDE93AE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612A37-F8FD-6B4C-9CF1-2FD00EFAD4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A4384-C4A2-B043-9A83-267BDE279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94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DBEDAC-E47A-B943-BDD0-0E79C867C9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9314" y="5940785"/>
            <a:ext cx="10515600" cy="646822"/>
          </a:xfrm>
        </p:spPr>
        <p:txBody>
          <a:bodyPr>
            <a:normAutofit fontScale="90000"/>
          </a:bodyPr>
          <a:lstStyle/>
          <a:p>
            <a:r>
              <a:rPr lang="en-GB" altLang="ja-JP" sz="26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altLang="ja-JP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Bland-Altman plot comparing SaO</a:t>
            </a:r>
            <a:r>
              <a:rPr lang="en-GB" altLang="ja-JP" sz="2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altLang="ja-JP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pO</a:t>
            </a:r>
            <a:r>
              <a:rPr lang="en-GB" altLang="ja-JP" sz="2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GB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ed from the raw data</a:t>
            </a:r>
            <a:endParaRPr lang="ja-JP" alt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プレースホルダー 5">
            <a:extLst>
              <a:ext uri="{FF2B5EF4-FFF2-40B4-BE49-F238E27FC236}">
                <a16:creationId xmlns:a16="http://schemas.microsoft.com/office/drawing/2014/main" id="{BF3C8E78-2660-0E4A-A414-9E6EBBCC6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61480" y="270393"/>
            <a:ext cx="5157787" cy="823912"/>
          </a:xfrm>
        </p:spPr>
        <p:txBody>
          <a:bodyPr>
            <a:normAutofit/>
          </a:bodyPr>
          <a:lstStyle/>
          <a:p>
            <a:pPr algn="ctr"/>
            <a:r>
              <a:rPr kumimoji="1" lang="en-GB" altLang="ja-JP" sz="2500" dirty="0"/>
              <a:t>Nihon Kohden</a:t>
            </a:r>
          </a:p>
        </p:txBody>
      </p:sp>
      <p:sp>
        <p:nvSpPr>
          <p:cNvPr id="12" name="テキスト プレースホルダー 7">
            <a:extLst>
              <a:ext uri="{FF2B5EF4-FFF2-40B4-BE49-F238E27FC236}">
                <a16:creationId xmlns:a16="http://schemas.microsoft.com/office/drawing/2014/main" id="{3737A3DC-0D8A-3645-899F-1A151C14D4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270393"/>
            <a:ext cx="5183188" cy="823912"/>
          </a:xfrm>
        </p:spPr>
        <p:txBody>
          <a:bodyPr>
            <a:normAutofit/>
          </a:bodyPr>
          <a:lstStyle/>
          <a:p>
            <a:pPr algn="ctr"/>
            <a:r>
              <a:rPr kumimoji="1" lang="en-GB" altLang="ja-JP" sz="2500" dirty="0"/>
              <a:t>Masimo</a:t>
            </a:r>
          </a:p>
        </p:txBody>
      </p:sp>
      <p:pic>
        <p:nvPicPr>
          <p:cNvPr id="13" name="Picture 1">
            <a:extLst>
              <a:ext uri="{FF2B5EF4-FFF2-40B4-BE49-F238E27FC236}">
                <a16:creationId xmlns:a16="http://schemas.microsoft.com/office/drawing/2014/main" id="{0DAE0134-048E-1041-AC25-B9074939EC75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6516114" y="1189037"/>
            <a:ext cx="4826572" cy="4622190"/>
          </a:xfrm>
          <a:prstGeom prst="rect">
            <a:avLst/>
          </a:prstGeom>
        </p:spPr>
      </p:pic>
      <p:pic>
        <p:nvPicPr>
          <p:cNvPr id="14" name="Picture 1">
            <a:extLst>
              <a:ext uri="{FF2B5EF4-FFF2-40B4-BE49-F238E27FC236}">
                <a16:creationId xmlns:a16="http://schemas.microsoft.com/office/drawing/2014/main" id="{09B548F1-13BA-9942-AE4A-C18E3F3C87AE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4"/>
          <a:stretch>
            <a:fillRect/>
          </a:stretch>
        </p:blipFill>
        <p:spPr>
          <a:xfrm>
            <a:off x="849314" y="1189037"/>
            <a:ext cx="4813871" cy="4610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0241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7</TotalTime>
  <Words>19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upplementary Figure S1. Bland-Altman plot comparing SaO2 and SpO2 analysed from the raw dat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Author</cp:lastModifiedBy>
  <cp:revision>62</cp:revision>
  <dcterms:created xsi:type="dcterms:W3CDTF">2020-02-09T11:47:42Z</dcterms:created>
  <dcterms:modified xsi:type="dcterms:W3CDTF">2020-06-09T03:33:35Z</dcterms:modified>
</cp:coreProperties>
</file>